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98" d="100"/>
          <a:sy n="98" d="100"/>
        </p:scale>
        <p:origin x="-1592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7912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65240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6487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755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80450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052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9995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072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0757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352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953112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2A538-0162-DE46-A2D8-B5F6C8F6561F}" type="datetimeFigureOut">
              <a:rPr lang="en-US" smtClean="0"/>
              <a:t>8/7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49F40-8B11-954A-90AA-FDF7361A8AF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81716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24452592"/>
              </p:ext>
            </p:extLst>
          </p:nvPr>
        </p:nvGraphicFramePr>
        <p:xfrm>
          <a:off x="685800" y="570285"/>
          <a:ext cx="7696200" cy="582342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700323"/>
                <a:gridCol w="2326758"/>
                <a:gridCol w="3669119"/>
              </a:tblGrid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>
                          <a:effectLst/>
                        </a:rPr>
                        <a:t>Phenotype category</a:t>
                      </a:r>
                      <a:endParaRPr lang="en-US" sz="10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>
                          <a:effectLst/>
                        </a:rPr>
                        <a:t>Image phenotype</a:t>
                      </a:r>
                      <a:endParaRPr lang="en-US" sz="10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000" b="1" u="none" strike="noStrike" dirty="0">
                          <a:effectLst/>
                        </a:rPr>
                        <a:t>Description</a:t>
                      </a:r>
                      <a:endParaRPr lang="en-US" sz="10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effectLst/>
                        </a:rPr>
                        <a:t>Size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Volume (mm</a:t>
                      </a:r>
                      <a:r>
                        <a:rPr lang="en-US" sz="800" u="none" strike="noStrike" baseline="30000" dirty="0">
                          <a:effectLst/>
                        </a:rPr>
                        <a:t>3</a:t>
                      </a:r>
                      <a:r>
                        <a:rPr lang="en-US" sz="800" u="none" strike="noStrike" dirty="0">
                          <a:effectLst/>
                        </a:rPr>
                        <a:t>)</a:t>
                      </a:r>
                      <a:endParaRPr lang="en-US" sz="800" b="0" i="0" u="none" strike="noStrike" dirty="0">
                        <a:solidFill>
                          <a:srgbClr val="1F497D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Volume of lesion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Effective diameter (mm)</a:t>
                      </a:r>
                      <a:endParaRPr lang="en-US" sz="800" b="0" i="0" u="none" strike="noStrike" dirty="0">
                        <a:solidFill>
                          <a:srgbClr val="1F497D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Diameter of a sphere with the same volume as the lesion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urface area (mm</a:t>
                      </a:r>
                      <a:r>
                        <a:rPr lang="en-US" sz="800" u="none" strike="noStrike" baseline="30000" dirty="0">
                          <a:effectLst/>
                        </a:rPr>
                        <a:t>2</a:t>
                      </a:r>
                      <a:r>
                        <a:rPr lang="en-US" sz="800" u="none" strike="noStrike" dirty="0">
                          <a:effectLst/>
                        </a:rPr>
                        <a:t>)</a:t>
                      </a:r>
                      <a:endParaRPr lang="en-US" sz="800" b="0" i="0" u="none" strike="noStrike" dirty="0">
                        <a:solidFill>
                          <a:srgbClr val="1F497D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Lesion surface area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Maximum linear size (mm)</a:t>
                      </a:r>
                      <a:endParaRPr lang="en-US" sz="800" b="0" i="0" u="none" strike="noStrike" dirty="0">
                        <a:solidFill>
                          <a:srgbClr val="1F497D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Maximum distance between any two voxels in the lesion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mpd="sng"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mpd="sng"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3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effectLst/>
                        </a:rPr>
                        <a:t>Shape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phericity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imilarity of the lesion shape to a sphere 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Irregularity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Deviation of the lesion surface from the surface of a sphere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urface area/volume (1/mm)</a:t>
                      </a:r>
                      <a:endParaRPr lang="en-US" sz="800" b="0" i="0" u="none" strike="noStrike" dirty="0">
                        <a:solidFill>
                          <a:srgbClr val="1F497D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Ratio of surface area to volume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effectLst/>
                        </a:rPr>
                        <a:t>Morphology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Margin sharpness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Mean of the image gradient at the lesion margin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Variance of margin sharpness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Variance of the image gradient at the lesion margin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Variance of radial gradient histogram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Degree to which the enhancement structure extends in a radial pattern originating from the center of the lesion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4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effectLst/>
                        </a:rPr>
                        <a:t>Enhancement Texture 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Contrast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Local image variations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Correlation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Image linearity 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Difference entropy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Randomness of the difference of neighboring voxels’ gray-levels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Difference variance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Variations of difference of gray-levels between voxel-pairs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Angular second moment (Energy)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Image homogeneity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Entropy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Randomness of the gray-levels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Inverse difference moment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Image homogeneity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Information measure of correlation (IMC)1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Nonlinear gray-level dependence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Information measure of correlation (IMC) 2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Nonlinear gray-level dependence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Maximum correlation coefficient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Nonlinear gray-level dependence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um average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Overall brightness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um entropy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Randomness of the sum of gray-levels of neighboring voxels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um variance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pread in the sum of the gray-levels of voxel-pairs distribution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um of squares (Variance)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pread in the gray-level distribution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6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effectLst/>
                        </a:rPr>
                        <a:t>Kinetic Curve Assessment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Maximum enhancement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Maximum contrast enhancement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Time to peak (s)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Time at which the maximum enhancement occurs 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Uptake rate (1/s)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Uptake speed of the contrast enhancement 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Washout rate (1/s)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Washout speed of the contrast enhancement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Curve shape index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Difference between late and early enhancement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Enhancement at first post-contrast time point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Enhancement at first post-contrast time point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Signal enhancement ratio 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Ratio of initial enhancement to overall enhancement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Volume of most enhancing voxels (mm</a:t>
                      </a:r>
                      <a:r>
                        <a:rPr lang="en-US" sz="800" u="none" strike="noStrike" baseline="30000" dirty="0">
                          <a:effectLst/>
                        </a:rPr>
                        <a:t>3</a:t>
                      </a:r>
                      <a:r>
                        <a:rPr lang="en-US" sz="800" u="none" strike="noStrike" dirty="0">
                          <a:effectLst/>
                        </a:rPr>
                        <a:t>)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Volume of the most enhancing voxels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Total rate variation (1/s</a:t>
                      </a:r>
                      <a:r>
                        <a:rPr lang="en-US" sz="800" u="none" strike="noStrike" baseline="30000" dirty="0">
                          <a:effectLst/>
                        </a:rPr>
                        <a:t>2</a:t>
                      </a:r>
                      <a:r>
                        <a:rPr lang="en-US" sz="800" u="none" strike="noStrike" dirty="0">
                          <a:effectLst/>
                        </a:rPr>
                        <a:t>)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How rapidly the contrast will enter and exit from the lesion 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Normalized total rate variation (1/s</a:t>
                      </a:r>
                      <a:r>
                        <a:rPr lang="en-US" sz="800" u="none" strike="noStrike" baseline="30000" dirty="0">
                          <a:effectLst/>
                        </a:rPr>
                        <a:t>2</a:t>
                      </a:r>
                      <a:r>
                        <a:rPr lang="en-US" sz="800" u="none" strike="noStrike" dirty="0">
                          <a:effectLst/>
                        </a:rPr>
                        <a:t>)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How rapidly the contrast will enter and exit from the lesion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1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b="1" u="none" strike="noStrike" dirty="0">
                          <a:effectLst/>
                        </a:rPr>
                        <a:t>Enhancement-Variance Kinetics 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Maximum variance of enhancement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Maximum spatial variance of contrast enhancement over time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Time to peak at maximum variance (s)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Time at which the maximum variance occurs 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Enhancement variance increasing rate (1/s)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Rate of increase of the enhancement-variance during uptake 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  <a:tr h="146538"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 </a:t>
                      </a:r>
                      <a:endParaRPr lang="en-US" sz="800" b="1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Enhancement variance decreasing rate (1/s)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800" u="none" strike="noStrike" dirty="0">
                          <a:effectLst/>
                        </a:rPr>
                        <a:t>Rate of decrease of the enhancement-variance during washout</a:t>
                      </a:r>
                      <a:endParaRPr lang="en-US" sz="800" b="0" i="0" u="none" strike="noStrike" dirty="0">
                        <a:solidFill>
                          <a:srgbClr val="365F91"/>
                        </a:solidFill>
                        <a:effectLst/>
                        <a:latin typeface="Cambria"/>
                      </a:endParaRPr>
                    </a:p>
                  </a:txBody>
                  <a:tcPr marL="2638" marR="2638" marT="2638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accent2">
                        <a:lumMod val="20000"/>
                        <a:lumOff val="80000"/>
                      </a:schemeClr>
                    </a:solidFill>
                  </a:tcPr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82057" y="41681"/>
            <a:ext cx="22886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emental Figure </a:t>
            </a:r>
            <a:r>
              <a:rPr lang="en-US" dirty="0" smtClean="0"/>
              <a:t>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134593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480</Words>
  <Application>Microsoft Macintosh PowerPoint</Application>
  <PresentationFormat>On-screen Show (4:3)</PresentationFormat>
  <Paragraphs>10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arvard Medical Schoo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Figure 1</dc:title>
  <dc:creator>Albert Yeh</dc:creator>
  <cp:lastModifiedBy>Albert Yeh</cp:lastModifiedBy>
  <cp:revision>8</cp:revision>
  <dcterms:created xsi:type="dcterms:W3CDTF">2016-05-28T19:49:17Z</dcterms:created>
  <dcterms:modified xsi:type="dcterms:W3CDTF">2016-08-08T01:51:02Z</dcterms:modified>
</cp:coreProperties>
</file>